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3" d="100"/>
          <a:sy n="103" d="100"/>
        </p:scale>
        <p:origin x="8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8A4B88-A931-4F92-BA24-C77639965C5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A1260E-78B3-4E33-83F8-DAF82D09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2315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A1260E-78B3-4E33-83F8-DAF82D09712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9388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A1260E-78B3-4E33-83F8-DAF82D097129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9388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DB1382-DF99-9C58-205B-58D803CFF2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3EBF7B-E474-9466-198C-1B8506D27F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ACB4D7-6A2F-3972-D3C0-2D4B139B6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C31783-0227-C376-3A46-DF64A1EC2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8C501E-57D4-4565-1998-FF67FE2F9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5125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12D0ED-E473-5845-4615-A6A1D7E02D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5BD20F-7125-E58F-6A6F-01BEA699B5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4FDAA9-01F3-9C4B-6D0D-5F642CF7D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DC7D5E-9FC1-7EA7-F85B-955C82B59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0CEA01-D4FE-FE8A-4A61-21B7BDD09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5806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176894-3D08-B6D9-6B59-E35D43367F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74B6F6-05B1-04A0-4984-69B8CDC964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3B8EF6-6232-1693-A167-86A3585C7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68E243-7DF4-15BC-2756-4C39AD832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789FC1-692D-B559-ADDE-6DE2E05EF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834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1F996-DADD-A6DD-E61A-D75AB1CFF8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BAA50E-253E-B68A-77F2-4C491882EC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4A529E-949C-2A02-5615-D2B1163AA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BE3B48-ADA8-6541-C42A-9F82CE29A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F5006-E9E7-FF50-A45A-272E93426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0828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A39DDC-B270-127C-C31F-FB742DA46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82CCF0-478C-174E-6F7D-8588648AFB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636A68-BFBA-718C-B44F-04BCA3114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2319C5-230A-1E59-CBB4-38315BDCA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8FEBB8-1D43-3DFF-60E5-651360449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7893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29E973-C4F0-6BEA-D327-BF0AFF3BE3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E3B706-0DCB-3B99-52E4-59A7BF4FC8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2B24EF-142D-6A2B-2B54-4F0BE90E54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614C7B-75E5-1DE1-389E-CBFD51B48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95E10-20C1-9428-C426-164663D26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D94EB5-4A09-25FB-B372-A07AAD121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98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565D1-A226-300A-86E2-3EF8B5AFAF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B76208-4DE0-7A2D-44AE-ABD2427550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67AD5B-1391-BDFD-D19B-7B8469FE7B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4F36574-5B94-C93C-1B4C-61D4EB2703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3CB5718-4DD4-EF9C-24E9-3354A12A53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3B9661-C400-C1FB-BB07-3C1F0B133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3620FE-4089-7127-0E32-3C8E66315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337069-7114-523D-2331-63102328E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053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CA3398-0C2D-B63E-C23B-412F645653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A9944E2-9CE6-E048-B1E1-3A8B33129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EBCCDD-EDF2-763F-E864-94A829FF6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42C502D-B44C-B17F-933F-49552F5CB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259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40A205D-1200-C3B3-6538-0AC0820E8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9489F1-D648-3F23-C0B2-A69854302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8144C0-6018-40AE-F6A1-91B2494EA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7098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9519E-487B-C3EE-892F-F33566EB42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2B8EF0-3AD9-7F08-3B6A-BF59D7EB4B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F1013D-7A0D-C527-B09E-E5EA9A5383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95EDF6-1D27-4C9D-76DA-628C750E9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7E0E8B-26D1-4B14-624D-F965C5A4E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81E489-D5E4-600E-F523-6937B212E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5167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4B8D46-9B05-2040-4336-FA8143D0B4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6D11AF4-6EB1-FB79-0060-F618B09944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30CFB8-325A-0D50-AA1E-A3939D4A02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BDB384-BF31-B15D-B56A-57DB9A6C0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C702B9-6256-417D-78B6-A86992DEE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79160-4545-E9CA-5B82-53DFBCD01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3406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3632DE-494D-A2AA-099F-4F2F344B6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5A5BC5-9235-29C3-48E8-7C9B27AC4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6CB0AE-AE5A-43FB-94EA-FD9FDF5B2C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A0A04B-D9A7-EFF6-D0E0-1B44F9E79A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9E15D6-D2FA-EEDF-1608-8175A2B2F0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749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ack and white photo of a black dot&#10;&#10;AI-generated content may be incorrect.">
            <a:extLst>
              <a:ext uri="{FF2B5EF4-FFF2-40B4-BE49-F238E27FC236}">
                <a16:creationId xmlns:a16="http://schemas.microsoft.com/office/drawing/2014/main" id="{D2629916-3F82-6A07-D59A-773DA7C532B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41" t="27479" r="33790" b="32783"/>
          <a:stretch>
            <a:fillRect/>
          </a:stretch>
        </p:blipFill>
        <p:spPr>
          <a:xfrm>
            <a:off x="4169231" y="1698171"/>
            <a:ext cx="2782075" cy="328437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C91BFB5A-4356-BE01-2BB3-CE318A508653}"/>
              </a:ext>
            </a:extLst>
          </p:cNvPr>
          <p:cNvSpPr/>
          <p:nvPr/>
        </p:nvSpPr>
        <p:spPr>
          <a:xfrm>
            <a:off x="5205489" y="3222038"/>
            <a:ext cx="992221" cy="6614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169FA9-1E0D-978D-81D5-7768305EFE49}"/>
              </a:ext>
            </a:extLst>
          </p:cNvPr>
          <p:cNvSpPr txBox="1"/>
          <p:nvPr/>
        </p:nvSpPr>
        <p:spPr>
          <a:xfrm>
            <a:off x="6232848" y="3412545"/>
            <a:ext cx="11663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N-WASP 65 </a:t>
            </a:r>
            <a:r>
              <a:rPr lang="en-GB" sz="1200" dirty="0" err="1"/>
              <a:t>kD</a:t>
            </a:r>
            <a:endParaRPr lang="en-GB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2388A6A-743E-8766-F04A-FB0459821E70}"/>
              </a:ext>
            </a:extLst>
          </p:cNvPr>
          <p:cNvSpPr txBox="1"/>
          <p:nvPr/>
        </p:nvSpPr>
        <p:spPr>
          <a:xfrm>
            <a:off x="4671526" y="2445271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8905649-1AE9-F488-3A6E-0D38D949FD13}"/>
              </a:ext>
            </a:extLst>
          </p:cNvPr>
          <p:cNvSpPr txBox="1"/>
          <p:nvPr/>
        </p:nvSpPr>
        <p:spPr>
          <a:xfrm>
            <a:off x="4948948" y="2445271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9374D4E-FA9B-D8D5-FED7-87F5B44FBA4F}"/>
              </a:ext>
            </a:extLst>
          </p:cNvPr>
          <p:cNvSpPr txBox="1"/>
          <p:nvPr/>
        </p:nvSpPr>
        <p:spPr>
          <a:xfrm>
            <a:off x="5226370" y="2445271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1091A44-02E7-8BFB-32B4-50CCECF103F3}"/>
              </a:ext>
            </a:extLst>
          </p:cNvPr>
          <p:cNvSpPr txBox="1"/>
          <p:nvPr/>
        </p:nvSpPr>
        <p:spPr>
          <a:xfrm>
            <a:off x="5503792" y="2445271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29F850C-87B8-C0E8-5BF0-63FF2F4B1FBC}"/>
              </a:ext>
            </a:extLst>
          </p:cNvPr>
          <p:cNvSpPr txBox="1"/>
          <p:nvPr/>
        </p:nvSpPr>
        <p:spPr>
          <a:xfrm>
            <a:off x="5781212" y="2445271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63EC245-B383-BC64-D405-EDCE5AC2B1BA}"/>
              </a:ext>
            </a:extLst>
          </p:cNvPr>
          <p:cNvSpPr txBox="1"/>
          <p:nvPr/>
        </p:nvSpPr>
        <p:spPr>
          <a:xfrm>
            <a:off x="7193902" y="1671753"/>
            <a:ext cx="233307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GB" sz="1200" dirty="0"/>
              <a:t>Wild-type</a:t>
            </a:r>
          </a:p>
          <a:p>
            <a:pPr marL="342900" indent="-342900">
              <a:buAutoNum type="arabicPeriod"/>
            </a:pPr>
            <a:r>
              <a:rPr lang="en-GB" sz="1200" dirty="0"/>
              <a:t>Non-target RNA</a:t>
            </a:r>
          </a:p>
          <a:p>
            <a:pPr marL="342900" indent="-342900">
              <a:buAutoNum type="arabicPeriod"/>
            </a:pPr>
            <a:r>
              <a:rPr lang="en-GB" sz="1200" dirty="0"/>
              <a:t>N-WASP KO</a:t>
            </a:r>
          </a:p>
          <a:p>
            <a:pPr marL="342900" indent="-342900">
              <a:buAutoNum type="arabicPeriod"/>
            </a:pPr>
            <a:r>
              <a:rPr lang="en-GB" sz="1200" dirty="0"/>
              <a:t>N-WASP KO + Empty vector</a:t>
            </a:r>
          </a:p>
          <a:p>
            <a:pPr marL="342900" indent="-342900">
              <a:buAutoNum type="arabicPeriod"/>
            </a:pPr>
            <a:r>
              <a:rPr lang="en-GB" sz="1200" dirty="0"/>
              <a:t>N-WASP KO + HA-N-WAS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52D13EC-DC7B-F754-6D13-A127E2A6DF06}"/>
              </a:ext>
            </a:extLst>
          </p:cNvPr>
          <p:cNvSpPr txBox="1"/>
          <p:nvPr/>
        </p:nvSpPr>
        <p:spPr>
          <a:xfrm>
            <a:off x="3851989" y="3231369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7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F075B4C-2067-ABEA-13DF-16ADF18EE52C}"/>
              </a:ext>
            </a:extLst>
          </p:cNvPr>
          <p:cNvSpPr txBox="1"/>
          <p:nvPr/>
        </p:nvSpPr>
        <p:spPr>
          <a:xfrm>
            <a:off x="3851989" y="3560375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5</a:t>
            </a:r>
          </a:p>
        </p:txBody>
      </p:sp>
    </p:spTree>
    <p:extLst>
      <p:ext uri="{BB962C8B-B14F-4D97-AF65-F5344CB8AC3E}">
        <p14:creationId xmlns:p14="http://schemas.microsoft.com/office/powerpoint/2010/main" val="3072273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ack and white photo of a black dot&#10;&#10;AI-generated content may be incorrect.">
            <a:extLst>
              <a:ext uri="{FF2B5EF4-FFF2-40B4-BE49-F238E27FC236}">
                <a16:creationId xmlns:a16="http://schemas.microsoft.com/office/drawing/2014/main" id="{D2629916-3F82-6A07-D59A-773DA7C532B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09" t="22624" r="56262" b="37637"/>
          <a:stretch>
            <a:fillRect/>
          </a:stretch>
        </p:blipFill>
        <p:spPr>
          <a:xfrm>
            <a:off x="4180115" y="1698171"/>
            <a:ext cx="2164702" cy="328437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C91BFB5A-4356-BE01-2BB3-CE318A508653}"/>
              </a:ext>
            </a:extLst>
          </p:cNvPr>
          <p:cNvSpPr/>
          <p:nvPr/>
        </p:nvSpPr>
        <p:spPr>
          <a:xfrm>
            <a:off x="5021095" y="3231369"/>
            <a:ext cx="992221" cy="6614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169FA9-1E0D-978D-81D5-7768305EFE49}"/>
              </a:ext>
            </a:extLst>
          </p:cNvPr>
          <p:cNvSpPr txBox="1"/>
          <p:nvPr/>
        </p:nvSpPr>
        <p:spPr>
          <a:xfrm>
            <a:off x="6232848" y="3412545"/>
            <a:ext cx="11663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/>
              <a:t>GAPDH 37 </a:t>
            </a:r>
            <a:r>
              <a:rPr lang="en-GB" sz="1200" dirty="0" err="1"/>
              <a:t>kD</a:t>
            </a:r>
            <a:endParaRPr lang="en-GB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2388A6A-743E-8766-F04A-FB0459821E70}"/>
              </a:ext>
            </a:extLst>
          </p:cNvPr>
          <p:cNvSpPr txBox="1"/>
          <p:nvPr/>
        </p:nvSpPr>
        <p:spPr>
          <a:xfrm>
            <a:off x="4466251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8905649-1AE9-F488-3A6E-0D38D949FD13}"/>
              </a:ext>
            </a:extLst>
          </p:cNvPr>
          <p:cNvSpPr txBox="1"/>
          <p:nvPr/>
        </p:nvSpPr>
        <p:spPr>
          <a:xfrm>
            <a:off x="4743673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9374D4E-FA9B-D8D5-FED7-87F5B44FBA4F}"/>
              </a:ext>
            </a:extLst>
          </p:cNvPr>
          <p:cNvSpPr txBox="1"/>
          <p:nvPr/>
        </p:nvSpPr>
        <p:spPr>
          <a:xfrm>
            <a:off x="5021095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1091A44-02E7-8BFB-32B4-50CCECF103F3}"/>
              </a:ext>
            </a:extLst>
          </p:cNvPr>
          <p:cNvSpPr txBox="1"/>
          <p:nvPr/>
        </p:nvSpPr>
        <p:spPr>
          <a:xfrm>
            <a:off x="529851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29F850C-87B8-C0E8-5BF0-63FF2F4B1FBC}"/>
              </a:ext>
            </a:extLst>
          </p:cNvPr>
          <p:cNvSpPr txBox="1"/>
          <p:nvPr/>
        </p:nvSpPr>
        <p:spPr>
          <a:xfrm>
            <a:off x="557593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63EC245-B383-BC64-D405-EDCE5AC2B1BA}"/>
              </a:ext>
            </a:extLst>
          </p:cNvPr>
          <p:cNvSpPr txBox="1"/>
          <p:nvPr/>
        </p:nvSpPr>
        <p:spPr>
          <a:xfrm>
            <a:off x="7193902" y="1671753"/>
            <a:ext cx="233307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GB" sz="1200" dirty="0"/>
              <a:t>Wild-type</a:t>
            </a:r>
          </a:p>
          <a:p>
            <a:pPr marL="342900" indent="-342900">
              <a:buAutoNum type="arabicPeriod"/>
            </a:pPr>
            <a:r>
              <a:rPr lang="en-GB" sz="1200" dirty="0"/>
              <a:t>Non-target RNA</a:t>
            </a:r>
          </a:p>
          <a:p>
            <a:pPr marL="342900" indent="-342900">
              <a:buAutoNum type="arabicPeriod"/>
            </a:pPr>
            <a:r>
              <a:rPr lang="en-GB" sz="1200" dirty="0"/>
              <a:t>N-WASP KO</a:t>
            </a:r>
          </a:p>
          <a:p>
            <a:pPr marL="342900" indent="-342900">
              <a:buAutoNum type="arabicPeriod"/>
            </a:pPr>
            <a:r>
              <a:rPr lang="en-GB" sz="1200" dirty="0"/>
              <a:t>N-WASP KO + Empty vector</a:t>
            </a:r>
          </a:p>
          <a:p>
            <a:pPr marL="342900" indent="-342900">
              <a:buAutoNum type="arabicPeriod"/>
            </a:pPr>
            <a:r>
              <a:rPr lang="en-GB" sz="1200" dirty="0"/>
              <a:t>N-WASP KO + HA-N-WAS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52D13EC-DC7B-F754-6D13-A127E2A6DF06}"/>
              </a:ext>
            </a:extLst>
          </p:cNvPr>
          <p:cNvSpPr txBox="1"/>
          <p:nvPr/>
        </p:nvSpPr>
        <p:spPr>
          <a:xfrm>
            <a:off x="3851989" y="3231369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F075B4C-2067-ABEA-13DF-16ADF18EE52C}"/>
              </a:ext>
            </a:extLst>
          </p:cNvPr>
          <p:cNvSpPr txBox="1"/>
          <p:nvPr/>
        </p:nvSpPr>
        <p:spPr>
          <a:xfrm>
            <a:off x="3851989" y="3560375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5</a:t>
            </a:r>
          </a:p>
        </p:txBody>
      </p:sp>
    </p:spTree>
    <p:extLst>
      <p:ext uri="{BB962C8B-B14F-4D97-AF65-F5344CB8AC3E}">
        <p14:creationId xmlns:p14="http://schemas.microsoft.com/office/powerpoint/2010/main" val="266623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0</Words>
  <Application>Microsoft Office PowerPoint</Application>
  <PresentationFormat>Widescreen</PresentationFormat>
  <Paragraphs>2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>SUND - K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han Thu Han Le</dc:creator>
  <cp:lastModifiedBy>Phan Thu Han Le</cp:lastModifiedBy>
  <cp:revision>3</cp:revision>
  <dcterms:created xsi:type="dcterms:W3CDTF">2025-12-11T11:13:17Z</dcterms:created>
  <dcterms:modified xsi:type="dcterms:W3CDTF">2025-12-11T11:35:01Z</dcterms:modified>
</cp:coreProperties>
</file>